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90" d="100"/>
          <a:sy n="90" d="100"/>
        </p:scale>
        <p:origin x="7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9DDB59-69CC-47D2-84ED-78CF8237B3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350C7F2-BFA3-4BB6-87BF-BCFE116EA9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3C00C0C-526A-4282-A5BC-F179C08A7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05FD16-21E1-478D-8488-92EBEB2B2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91346B5-2562-46F8-A345-E446F8144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4599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B3C779-ACF8-4893-A6AD-34EC8CD08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DE0D4FD-C7D9-4D12-9820-A095D7015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60F1A05-060D-497A-9B4C-9527A460F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235D7D-E334-4826-8C68-3C76983A4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B40F69F-6523-41C1-AD8B-9D017CB88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8716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52708ED-2C7D-42E5-B566-D10340422B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14062EC-5774-4FEB-8396-7542600C9F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5D9EACC-6FD0-46CD-B3D5-BE737CB5D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50FF55A-1712-4C8C-92E0-1836B1984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608B034-A8F6-4CED-B4DC-528DD0972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795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E00172-BE6D-45BA-9183-E32B6C05B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4A649E8-98CF-4B2A-9F58-D50FEF9293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6F33BFE-7305-400C-AB8F-66D3866F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0E19C0C-3268-497E-923A-C4F0FFA9A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D3F2378-2179-40C1-B070-8D69C1E9E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1843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BCDA0B-5C03-4D0D-A43E-174ABE7AB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C5A1A9F-B0E2-4253-8A18-632377C43B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C423BB-882D-4807-B3CE-0B216B4E8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DBE53DD-7E0C-40F7-835C-49BE6F824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CF5881-43FD-4392-9834-378F161F7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0863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B0639F2-E266-4120-83AF-2B068275B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D61FF1-F3E2-43DC-AC0A-6F5B9919BE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3CE3F77-17FF-4196-9E26-03A179EF29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6F92574-AABE-4622-8670-A9C0BB6CF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D235981-C998-405C-998A-2DB22987B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BB6C519-BD9E-43BE-A23F-856B42F31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3253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5075FCD-719D-463B-AD15-029C4C761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F30255-AF8A-4814-974A-E6757595D9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17FAD4F-49B8-41A0-A0D0-99E213321E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7EF5478-9C5B-4F2E-B367-1299C8834D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FF1C042-6BFB-48CE-932E-1311113CC8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599CEC2-F04F-433E-B31D-41B45ED26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FABC5DA-F651-41FC-BC3E-CD8EF2FF0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66FBE35-D534-4B7E-9431-69EAAA5C8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913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69E3FE-2DDA-4CB6-87A1-509E294537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82399F8-C996-414D-BBB0-C85DFDE7A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D1A4E13-923D-4EA3-9746-C05D6D314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6818623-1109-4193-8AC2-11A8801F9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5110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4D5A1A3-A34A-4C6D-AAD3-A13409DFA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B7B556-1CB3-4D20-BB25-1DD87AC15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CA61648-4ED9-4BE8-AC94-0EE5B48BA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201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4E73CE-BA3B-480D-B394-3FF149E55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F3A79A6-472C-47FD-8103-81F3325BE7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6833AC5-1696-49D4-80A5-A0085F35E0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194E972-014F-442D-B362-98E5DB7E7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5828009-3326-4A52-99C5-66BA6362F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32D2223-ED4C-4A56-9DF6-78759D5EC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3477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994DC9-1BDC-44CA-A6F0-AD36160F7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D09E7EE-56A5-4CC2-A816-D00C72CE92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94F6CA-1C11-4AEE-BA50-9EE025EF8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0064D72-31BB-417E-A247-F49261E1A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284B1EB-39B5-4AA2-820C-61EC9BDC9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353563B-FFC3-44AF-8B2B-3898F75BC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1366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4312565-146E-4968-857F-558F434D08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723CD48-35B4-4C5D-9E17-ED3224A730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40C0E47-F5C3-4691-959A-F8C4D1A2A9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83957-4332-4C47-A52D-9E4CD3556FD0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168B21-20B0-4BDE-8370-AA6104EA9A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18C443A-D8AE-4FCA-BFD3-A99A401A57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0EBC5-0E03-4F34-BE32-B34E61D496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4385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207579" y="247680"/>
            <a:ext cx="11617496" cy="6427472"/>
            <a:chOff x="102479" y="247680"/>
            <a:chExt cx="11617496" cy="6427472"/>
          </a:xfrm>
        </p:grpSpPr>
        <p:pic>
          <p:nvPicPr>
            <p:cNvPr id="11268" name="Picture 4" descr="C:\Users\trs-confocal\AppData\Local\Temp\tmp04282335797193208428.pn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40322" y="291263"/>
              <a:ext cx="1936171" cy="2027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271" name="Picture 7" descr="C:\Users\trs-confocal\AppData\Local\Temp\tmp04024065557684463320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602" y="4647783"/>
              <a:ext cx="1936172" cy="20273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274" name="Picture 10" descr="C:\Users\trs-confocal\AppData\Local\Temp\tmp09163030676714810146.pn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14058" y="2415315"/>
              <a:ext cx="1936173" cy="20273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4" descr="C:\Users\trs-confocal\AppData\Local\Temp\tmp15820303112816020023.png">
              <a:extLst>
                <a:ext uri="{FF2B5EF4-FFF2-40B4-BE49-F238E27FC236}">
                  <a16:creationId xmlns:a16="http://schemas.microsoft.com/office/drawing/2014/main" id="{23DC3DF1-4F0C-4488-BDCE-8326D094E7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82477" y="272721"/>
              <a:ext cx="1936170" cy="20273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2" descr="C:\Users\trs-confocal\AppData\Local\Temp\tmp18795999843453446024.png">
              <a:extLst>
                <a:ext uri="{FF2B5EF4-FFF2-40B4-BE49-F238E27FC236}">
                  <a16:creationId xmlns:a16="http://schemas.microsoft.com/office/drawing/2014/main" id="{12612871-6767-4983-AB75-AF57705748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86657" y="2447196"/>
              <a:ext cx="1905726" cy="19954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8" descr="C:\Users\trs-confocal\AppData\Local\Temp\tmp13354806218517716933.png">
              <a:extLst>
                <a:ext uri="{FF2B5EF4-FFF2-40B4-BE49-F238E27FC236}">
                  <a16:creationId xmlns:a16="http://schemas.microsoft.com/office/drawing/2014/main" id="{F39E5A92-CD64-4A63-A2CA-2E34AFA0494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03416" y="4681273"/>
              <a:ext cx="1872208" cy="19603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7D068381-654B-455A-8AD6-DD61C7C23104}"/>
                </a:ext>
              </a:extLst>
            </p:cNvPr>
            <p:cNvSpPr txBox="1"/>
            <p:nvPr/>
          </p:nvSpPr>
          <p:spPr>
            <a:xfrm>
              <a:off x="5507273" y="5094732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ndo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218647" y="288229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ndo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239658" y="2260156"/>
              <a:ext cx="20123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fr-FR" sz="1400" b="1" dirty="0" err="1"/>
                <a:t>wild</a:t>
              </a:r>
              <a:r>
                <a:rPr lang="fr-FR" sz="1400" b="1" dirty="0"/>
                <a:t>-type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218647" y="3688941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102479" y="4452022"/>
              <a:ext cx="25378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3</a:t>
              </a:r>
              <a:r>
                <a:rPr lang="el-GR" sz="1400" b="1" dirty="0"/>
                <a:t>Δ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2C50DD77-AD82-4A09-9D1B-BA65F43B8CE2}"/>
                </a:ext>
              </a:extLst>
            </p:cNvPr>
            <p:cNvSpPr txBox="1"/>
            <p:nvPr/>
          </p:nvSpPr>
          <p:spPr>
            <a:xfrm>
              <a:off x="5470741" y="2826662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ndo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1385067D-7DB2-4E0E-89AA-BA4E85F051C4}"/>
                </a:ext>
              </a:extLst>
            </p:cNvPr>
            <p:cNvSpPr txBox="1"/>
            <p:nvPr/>
          </p:nvSpPr>
          <p:spPr>
            <a:xfrm>
              <a:off x="9236479" y="509473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ndo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236479" y="600816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507273" y="573170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endothelial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sp>
        <p:nvSpPr>
          <p:cNvPr id="6" name="ZoneTexte 5">
            <a:extLst>
              <a:ext uri="{FF2B5EF4-FFF2-40B4-BE49-F238E27FC236}">
                <a16:creationId xmlns:a16="http://schemas.microsoft.com/office/drawing/2014/main" id="{60E2C396-46D9-42DF-A2DB-528A1159EC05}"/>
              </a:ext>
            </a:extLst>
          </p:cNvPr>
          <p:cNvSpPr txBox="1"/>
          <p:nvPr/>
        </p:nvSpPr>
        <p:spPr>
          <a:xfrm>
            <a:off x="10205545" y="291263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6 </a:t>
            </a:r>
            <a:r>
              <a:rPr lang="fr-FR" b="1" dirty="0" err="1"/>
              <a:t>Fig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32883589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2</cp:revision>
  <dcterms:created xsi:type="dcterms:W3CDTF">2020-06-04T06:30:54Z</dcterms:created>
  <dcterms:modified xsi:type="dcterms:W3CDTF">2020-09-18T09:08:06Z</dcterms:modified>
</cp:coreProperties>
</file>